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>
        <p:scale>
          <a:sx n="150" d="100"/>
          <a:sy n="150" d="100"/>
        </p:scale>
        <p:origin x="654" y="2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ekle Pauzaite" userId="06f7e524-8501-4f81-9b2a-484f6f2c7061" providerId="ADAL" clId="{0F8F4826-D65A-4763-AD81-579684985EE3}"/>
    <pc:docChg chg="addSld modSld">
      <pc:chgData name="Tekle Pauzaite" userId="06f7e524-8501-4f81-9b2a-484f6f2c7061" providerId="ADAL" clId="{0F8F4826-D65A-4763-AD81-579684985EE3}" dt="2024-03-27T11:10:27.983" v="98" actId="571"/>
      <pc:docMkLst>
        <pc:docMk/>
      </pc:docMkLst>
      <pc:sldChg chg="addSp delSp modSp add">
        <pc:chgData name="Tekle Pauzaite" userId="06f7e524-8501-4f81-9b2a-484f6f2c7061" providerId="ADAL" clId="{0F8F4826-D65A-4763-AD81-579684985EE3}" dt="2024-03-27T11:10:27.983" v="98" actId="571"/>
        <pc:sldMkLst>
          <pc:docMk/>
          <pc:sldMk cId="2756049766" sldId="256"/>
        </pc:sldMkLst>
        <pc:spChg chg="del">
          <ac:chgData name="Tekle Pauzaite" userId="06f7e524-8501-4f81-9b2a-484f6f2c7061" providerId="ADAL" clId="{0F8F4826-D65A-4763-AD81-579684985EE3}" dt="2024-03-27T11:07:17.877" v="1"/>
          <ac:spMkLst>
            <pc:docMk/>
            <pc:sldMk cId="2756049766" sldId="256"/>
            <ac:spMk id="2" creationId="{8D3534DC-F4D9-4094-A9B4-C0AEF918D9E1}"/>
          </ac:spMkLst>
        </pc:spChg>
        <pc:spChg chg="del">
          <ac:chgData name="Tekle Pauzaite" userId="06f7e524-8501-4f81-9b2a-484f6f2c7061" providerId="ADAL" clId="{0F8F4826-D65A-4763-AD81-579684985EE3}" dt="2024-03-27T11:07:17.877" v="1"/>
          <ac:spMkLst>
            <pc:docMk/>
            <pc:sldMk cId="2756049766" sldId="256"/>
            <ac:spMk id="3" creationId="{EF7D95E5-26FA-4181-90C8-0650D3E5DA6C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" creationId="{5AF1C5D3-4B59-45D8-A1BF-7C64496C0A45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6" creationId="{47009CA7-812B-4845-968F-68837B668B85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9" creationId="{29BD76FB-DF3E-452F-B97F-3C8C82159399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10" creationId="{5E0ECA59-7F88-4261-AB19-94464C4D12A9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11" creationId="{6A1A4486-7FD2-4CC8-951A-B36E78A8FAF4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16" creationId="{4D730270-80FE-4B84-9BCC-FA7967000A6E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17" creationId="{B98CAA9C-2809-4EBC-B788-269365BC00E5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19" creationId="{2FADDEA5-805C-4054-9B32-E5ED4A7248C4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0" creationId="{253E61FD-50CD-4DAE-BF2A-CD7CE8B49319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1" creationId="{41C5F901-A37F-4E04-9A04-03145026D227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2" creationId="{054DFFA6-560B-4039-955C-9A050C86EC10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3" creationId="{61415845-DADA-4CFD-9414-1A29A42FF13D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4" creationId="{D8E46F8D-CEEB-4DA2-B859-4260A8946C74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5" creationId="{70E092B7-09AC-4796-9C00-33B8369E1B86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6" creationId="{382977CB-9068-4282-A673-112C9CE5AE8C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7" creationId="{0F6F5B8A-73E9-4571-861B-6A27A261B8F3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8" creationId="{784B4BE7-121F-4484-B474-62B3992DFE9C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29" creationId="{2B173EBC-E6AC-4A20-8B71-D9687DFDDF3E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0" creationId="{F15ED44D-25CD-434C-A599-DC86BF67EBDF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1" creationId="{466552DE-3526-4D96-A2B5-78B2E48F3C09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2" creationId="{6ED9D7B4-5D5B-4E6A-94E4-49190C66DA4B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3" creationId="{B85F809A-DDF7-451F-A679-03563F7B1FA5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4" creationId="{A9C1EBA1-05FF-4CAC-988D-320F774ECF7F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5" creationId="{F1E085C2-9CFA-452A-B8DC-295D85FEB17E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6" creationId="{850063B5-8179-4CA4-BBCB-7179FBB97ED6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7" creationId="{491BCA8B-4C2B-476E-B23A-47E684A186FA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8" creationId="{A89BC0E5-19E2-468B-BBDC-D251D63C0309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39" creationId="{D3EDA05F-EB50-4D73-AA29-41A29FDE9573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0" creationId="{6A4D5434-757E-45AE-AD90-BD0F818ACC33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1" creationId="{AAA0B5F1-A151-4FB7-99E3-0A3F6CCE9F1C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2" creationId="{0C61A79C-C6EC-4DA4-8FAA-578AB147BFE7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3" creationId="{45216A81-A4DB-4CD7-AB97-0F7BCE21D4C2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4" creationId="{84241137-40AB-4A14-B7B7-A9CFF4392585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5" creationId="{DBCB27EA-CE37-4EC6-9915-6E781D90B120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6" creationId="{638A4CCE-6BFD-4F9F-9BB9-4075FC8A502E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7" creationId="{4928D9B2-4AF0-4CB2-B042-EEDFE630CC33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8" creationId="{E1DAE6C8-2DEC-467F-846B-5B1D85C1C043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49" creationId="{C982DEBB-2AE4-48E8-93F4-9D6741DB6C5E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0" creationId="{E4536AF7-34B6-4602-AD86-0E499B02E955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1" creationId="{27607EC0-8CD4-41C3-BBCF-3ED53C78346E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2" creationId="{C1749917-D6C0-4DBD-8394-9BE92114AC40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3" creationId="{06DE911C-B93F-4A2F-B9CD-51BA099404BB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4" creationId="{403824B4-8CDC-4B7C-BD9A-AE06E6E3C833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5" creationId="{9FB4FF72-DF2C-4F04-ABAC-C59515CF50A5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7" creationId="{CEAD1344-1F1A-4256-A12F-4465466EC74A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59" creationId="{0A897402-42E8-4E9C-AECE-47E5A89D9871}"/>
          </ac:spMkLst>
        </pc:spChg>
        <pc:spChg chg="mod topLvl">
          <ac:chgData name="Tekle Pauzaite" userId="06f7e524-8501-4f81-9b2a-484f6f2c7061" providerId="ADAL" clId="{0F8F4826-D65A-4763-AD81-579684985EE3}" dt="2024-03-27T11:07:30.289" v="4" actId="165"/>
          <ac:spMkLst>
            <pc:docMk/>
            <pc:sldMk cId="2756049766" sldId="256"/>
            <ac:spMk id="61" creationId="{17949836-AA45-4822-94FF-517ED9B50553}"/>
          </ac:spMkLst>
        </pc:spChg>
        <pc:spChg chg="add mod">
          <ac:chgData name="Tekle Pauzaite" userId="06f7e524-8501-4f81-9b2a-484f6f2c7061" providerId="ADAL" clId="{0F8F4826-D65A-4763-AD81-579684985EE3}" dt="2024-03-27T11:07:23.773" v="3" actId="1076"/>
          <ac:spMkLst>
            <pc:docMk/>
            <pc:sldMk cId="2756049766" sldId="256"/>
            <ac:spMk id="63" creationId="{9940B4AC-227C-4E4C-A606-1C7C3D82EDBC}"/>
          </ac:spMkLst>
        </pc:spChg>
        <pc:spChg chg="add mod">
          <ac:chgData name="Tekle Pauzaite" userId="06f7e524-8501-4f81-9b2a-484f6f2c7061" providerId="ADAL" clId="{0F8F4826-D65A-4763-AD81-579684985EE3}" dt="2024-03-27T11:07:23.773" v="3" actId="1076"/>
          <ac:spMkLst>
            <pc:docMk/>
            <pc:sldMk cId="2756049766" sldId="256"/>
            <ac:spMk id="64" creationId="{F8DAE4BA-B1F3-444E-8FF9-7E40E34BBA8E}"/>
          </ac:spMkLst>
        </pc:spChg>
        <pc:spChg chg="add mod">
          <ac:chgData name="Tekle Pauzaite" userId="06f7e524-8501-4f81-9b2a-484f6f2c7061" providerId="ADAL" clId="{0F8F4826-D65A-4763-AD81-579684985EE3}" dt="2024-03-27T11:09:50.446" v="86" actId="208"/>
          <ac:spMkLst>
            <pc:docMk/>
            <pc:sldMk cId="2756049766" sldId="256"/>
            <ac:spMk id="70" creationId="{406C0133-FFBF-4734-A53C-B5B55148CE3C}"/>
          </ac:spMkLst>
        </pc:spChg>
        <pc:spChg chg="add mod">
          <ac:chgData name="Tekle Pauzaite" userId="06f7e524-8501-4f81-9b2a-484f6f2c7061" providerId="ADAL" clId="{0F8F4826-D65A-4763-AD81-579684985EE3}" dt="2024-03-27T11:09:56.806" v="88" actId="14100"/>
          <ac:spMkLst>
            <pc:docMk/>
            <pc:sldMk cId="2756049766" sldId="256"/>
            <ac:spMk id="71" creationId="{3396487E-6A46-4441-8127-331C1A46DE7E}"/>
          </ac:spMkLst>
        </pc:spChg>
        <pc:spChg chg="add mod">
          <ac:chgData name="Tekle Pauzaite" userId="06f7e524-8501-4f81-9b2a-484f6f2c7061" providerId="ADAL" clId="{0F8F4826-D65A-4763-AD81-579684985EE3}" dt="2024-03-27T11:09:59.207" v="89" actId="571"/>
          <ac:spMkLst>
            <pc:docMk/>
            <pc:sldMk cId="2756049766" sldId="256"/>
            <ac:spMk id="72" creationId="{43E955FF-A5D7-402B-A544-BB83BDD3D85E}"/>
          </ac:spMkLst>
        </pc:spChg>
        <pc:spChg chg="add mod">
          <ac:chgData name="Tekle Pauzaite" userId="06f7e524-8501-4f81-9b2a-484f6f2c7061" providerId="ADAL" clId="{0F8F4826-D65A-4763-AD81-579684985EE3}" dt="2024-03-27T11:10:04.070" v="91" actId="14100"/>
          <ac:spMkLst>
            <pc:docMk/>
            <pc:sldMk cId="2756049766" sldId="256"/>
            <ac:spMk id="73" creationId="{8528722F-5DA7-41DB-881E-B619D44592F4}"/>
          </ac:spMkLst>
        </pc:spChg>
        <pc:spChg chg="add mod">
          <ac:chgData name="Tekle Pauzaite" userId="06f7e524-8501-4f81-9b2a-484f6f2c7061" providerId="ADAL" clId="{0F8F4826-D65A-4763-AD81-579684985EE3}" dt="2024-03-27T11:10:10.222" v="93" actId="14100"/>
          <ac:spMkLst>
            <pc:docMk/>
            <pc:sldMk cId="2756049766" sldId="256"/>
            <ac:spMk id="74" creationId="{9AC97B8D-87B7-4A9A-B171-E60D497FBAB9}"/>
          </ac:spMkLst>
        </pc:spChg>
        <pc:spChg chg="add mod">
          <ac:chgData name="Tekle Pauzaite" userId="06f7e524-8501-4f81-9b2a-484f6f2c7061" providerId="ADAL" clId="{0F8F4826-D65A-4763-AD81-579684985EE3}" dt="2024-03-27T11:10:14.583" v="94" actId="571"/>
          <ac:spMkLst>
            <pc:docMk/>
            <pc:sldMk cId="2756049766" sldId="256"/>
            <ac:spMk id="75" creationId="{7421FF90-EF08-4324-BA9A-BC463F7CADB7}"/>
          </ac:spMkLst>
        </pc:spChg>
        <pc:spChg chg="add mod">
          <ac:chgData name="Tekle Pauzaite" userId="06f7e524-8501-4f81-9b2a-484f6f2c7061" providerId="ADAL" clId="{0F8F4826-D65A-4763-AD81-579684985EE3}" dt="2024-03-27T11:10:17.559" v="95" actId="571"/>
          <ac:spMkLst>
            <pc:docMk/>
            <pc:sldMk cId="2756049766" sldId="256"/>
            <ac:spMk id="76" creationId="{CF35BC04-FDAD-4D9F-8FC3-97D20BECED39}"/>
          </ac:spMkLst>
        </pc:spChg>
        <pc:spChg chg="add mod">
          <ac:chgData name="Tekle Pauzaite" userId="06f7e524-8501-4f81-9b2a-484f6f2c7061" providerId="ADAL" clId="{0F8F4826-D65A-4763-AD81-579684985EE3}" dt="2024-03-27T11:10:19.943" v="96" actId="571"/>
          <ac:spMkLst>
            <pc:docMk/>
            <pc:sldMk cId="2756049766" sldId="256"/>
            <ac:spMk id="77" creationId="{F44FE8D8-DEE7-469E-8582-D01873D9BC54}"/>
          </ac:spMkLst>
        </pc:spChg>
        <pc:spChg chg="add mod">
          <ac:chgData name="Tekle Pauzaite" userId="06f7e524-8501-4f81-9b2a-484f6f2c7061" providerId="ADAL" clId="{0F8F4826-D65A-4763-AD81-579684985EE3}" dt="2024-03-27T11:10:23.511" v="97" actId="571"/>
          <ac:spMkLst>
            <pc:docMk/>
            <pc:sldMk cId="2756049766" sldId="256"/>
            <ac:spMk id="78" creationId="{06C713D9-581D-49A5-8192-F270505EC285}"/>
          </ac:spMkLst>
        </pc:spChg>
        <pc:spChg chg="add mod">
          <ac:chgData name="Tekle Pauzaite" userId="06f7e524-8501-4f81-9b2a-484f6f2c7061" providerId="ADAL" clId="{0F8F4826-D65A-4763-AD81-579684985EE3}" dt="2024-03-27T11:10:27.983" v="98" actId="571"/>
          <ac:spMkLst>
            <pc:docMk/>
            <pc:sldMk cId="2756049766" sldId="256"/>
            <ac:spMk id="79" creationId="{7EA4CAEE-D3AD-402B-B0B5-47DA2F374059}"/>
          </ac:spMkLst>
        </pc:spChg>
        <pc:grpChg chg="add del mod">
          <ac:chgData name="Tekle Pauzaite" userId="06f7e524-8501-4f81-9b2a-484f6f2c7061" providerId="ADAL" clId="{0F8F4826-D65A-4763-AD81-579684985EE3}" dt="2024-03-27T11:07:30.289" v="4" actId="165"/>
          <ac:grpSpMkLst>
            <pc:docMk/>
            <pc:sldMk cId="2756049766" sldId="256"/>
            <ac:grpSpMk id="4" creationId="{B79FDA28-2685-40F3-A7E1-99E3FB4CC17A}"/>
          </ac:grpSpMkLst>
        </pc:grpChg>
        <pc:picChg chg="mod topLvl">
          <ac:chgData name="Tekle Pauzaite" userId="06f7e524-8501-4f81-9b2a-484f6f2c7061" providerId="ADAL" clId="{0F8F4826-D65A-4763-AD81-579684985EE3}" dt="2024-03-27T11:07:30.289" v="4" actId="165"/>
          <ac:picMkLst>
            <pc:docMk/>
            <pc:sldMk cId="2756049766" sldId="256"/>
            <ac:picMk id="12" creationId="{D0C84689-3865-41AE-9E74-17D0E85A72A7}"/>
          </ac:picMkLst>
        </pc:picChg>
        <pc:picChg chg="mod topLvl">
          <ac:chgData name="Tekle Pauzaite" userId="06f7e524-8501-4f81-9b2a-484f6f2c7061" providerId="ADAL" clId="{0F8F4826-D65A-4763-AD81-579684985EE3}" dt="2024-03-27T11:07:30.289" v="4" actId="165"/>
          <ac:picMkLst>
            <pc:docMk/>
            <pc:sldMk cId="2756049766" sldId="256"/>
            <ac:picMk id="13" creationId="{F5D65AFD-FF95-4604-8E97-A4654D2FD74E}"/>
          </ac:picMkLst>
        </pc:picChg>
        <pc:picChg chg="mod topLvl">
          <ac:chgData name="Tekle Pauzaite" userId="06f7e524-8501-4f81-9b2a-484f6f2c7061" providerId="ADAL" clId="{0F8F4826-D65A-4763-AD81-579684985EE3}" dt="2024-03-27T11:07:30.289" v="4" actId="165"/>
          <ac:picMkLst>
            <pc:docMk/>
            <pc:sldMk cId="2756049766" sldId="256"/>
            <ac:picMk id="14" creationId="{44BE81CB-9977-4F9B-B12D-C2C0D975E0CB}"/>
          </ac:picMkLst>
        </pc:picChg>
        <pc:picChg chg="mod topLvl">
          <ac:chgData name="Tekle Pauzaite" userId="06f7e524-8501-4f81-9b2a-484f6f2c7061" providerId="ADAL" clId="{0F8F4826-D65A-4763-AD81-579684985EE3}" dt="2024-03-27T11:07:30.289" v="4" actId="165"/>
          <ac:picMkLst>
            <pc:docMk/>
            <pc:sldMk cId="2756049766" sldId="256"/>
            <ac:picMk id="15" creationId="{7F994290-02E8-4746-9029-929E7B86DA7A}"/>
          </ac:picMkLst>
        </pc:picChg>
        <pc:picChg chg="mod topLvl">
          <ac:chgData name="Tekle Pauzaite" userId="06f7e524-8501-4f81-9b2a-484f6f2c7061" providerId="ADAL" clId="{0F8F4826-D65A-4763-AD81-579684985EE3}" dt="2024-03-27T11:07:30.289" v="4" actId="165"/>
          <ac:picMkLst>
            <pc:docMk/>
            <pc:sldMk cId="2756049766" sldId="256"/>
            <ac:picMk id="18" creationId="{661D6D28-1DAA-45C3-8ABE-12000F61928B}"/>
          </ac:picMkLst>
        </pc:picChg>
        <pc:picChg chg="add mod modCrop">
          <ac:chgData name="Tekle Pauzaite" userId="06f7e524-8501-4f81-9b2a-484f6f2c7061" providerId="ADAL" clId="{0F8F4826-D65A-4763-AD81-579684985EE3}" dt="2024-03-27T11:08:56.682" v="67" actId="1038"/>
          <ac:picMkLst>
            <pc:docMk/>
            <pc:sldMk cId="2756049766" sldId="256"/>
            <ac:picMk id="65" creationId="{C4BA063E-FCE6-4657-B87A-A77DEDA977AB}"/>
          </ac:picMkLst>
        </pc:picChg>
        <pc:picChg chg="add mod modCrop">
          <ac:chgData name="Tekle Pauzaite" userId="06f7e524-8501-4f81-9b2a-484f6f2c7061" providerId="ADAL" clId="{0F8F4826-D65A-4763-AD81-579684985EE3}" dt="2024-03-27T11:08:56.682" v="67" actId="1038"/>
          <ac:picMkLst>
            <pc:docMk/>
            <pc:sldMk cId="2756049766" sldId="256"/>
            <ac:picMk id="66" creationId="{A48C75BE-79A7-4532-81E4-15FC355C5757}"/>
          </ac:picMkLst>
        </pc:picChg>
        <pc:picChg chg="add mod modCrop">
          <ac:chgData name="Tekle Pauzaite" userId="06f7e524-8501-4f81-9b2a-484f6f2c7061" providerId="ADAL" clId="{0F8F4826-D65A-4763-AD81-579684985EE3}" dt="2024-03-27T11:09:00.382" v="68" actId="1076"/>
          <ac:picMkLst>
            <pc:docMk/>
            <pc:sldMk cId="2756049766" sldId="256"/>
            <ac:picMk id="67" creationId="{91B82F13-FA74-43A8-9590-6824BF300979}"/>
          </ac:picMkLst>
        </pc:picChg>
        <pc:picChg chg="add mod modCrop">
          <ac:chgData name="Tekle Pauzaite" userId="06f7e524-8501-4f81-9b2a-484f6f2c7061" providerId="ADAL" clId="{0F8F4826-D65A-4763-AD81-579684985EE3}" dt="2024-03-27T11:09:15.206" v="75" actId="1076"/>
          <ac:picMkLst>
            <pc:docMk/>
            <pc:sldMk cId="2756049766" sldId="256"/>
            <ac:picMk id="68" creationId="{ACE4C112-8E02-41C2-959D-4EF8155BF6D2}"/>
          </ac:picMkLst>
        </pc:picChg>
        <pc:picChg chg="add mod modCrop">
          <ac:chgData name="Tekle Pauzaite" userId="06f7e524-8501-4f81-9b2a-484f6f2c7061" providerId="ADAL" clId="{0F8F4826-D65A-4763-AD81-579684985EE3}" dt="2024-03-27T11:09:31.806" v="83" actId="1076"/>
          <ac:picMkLst>
            <pc:docMk/>
            <pc:sldMk cId="2756049766" sldId="256"/>
            <ac:picMk id="69" creationId="{0323699D-90EB-4A80-9DCF-5FF14DFE852B}"/>
          </ac:picMkLst>
        </pc:picChg>
        <pc:cxnChg chg="mod topLvl">
          <ac:chgData name="Tekle Pauzaite" userId="06f7e524-8501-4f81-9b2a-484f6f2c7061" providerId="ADAL" clId="{0F8F4826-D65A-4763-AD81-579684985EE3}" dt="2024-03-27T11:07:30.289" v="4" actId="165"/>
          <ac:cxnSpMkLst>
            <pc:docMk/>
            <pc:sldMk cId="2756049766" sldId="256"/>
            <ac:cxnSpMk id="7" creationId="{85F5DB18-BFEB-4AFF-8A3C-B440A34A8131}"/>
          </ac:cxnSpMkLst>
        </pc:cxnChg>
        <pc:cxnChg chg="mod topLvl">
          <ac:chgData name="Tekle Pauzaite" userId="06f7e524-8501-4f81-9b2a-484f6f2c7061" providerId="ADAL" clId="{0F8F4826-D65A-4763-AD81-579684985EE3}" dt="2024-03-27T11:07:30.289" v="4" actId="165"/>
          <ac:cxnSpMkLst>
            <pc:docMk/>
            <pc:sldMk cId="2756049766" sldId="256"/>
            <ac:cxnSpMk id="8" creationId="{CE6D4E57-0505-4F0C-B2CA-91536D6F5101}"/>
          </ac:cxnSpMkLst>
        </pc:cxnChg>
        <pc:cxnChg chg="mod topLvl">
          <ac:chgData name="Tekle Pauzaite" userId="06f7e524-8501-4f81-9b2a-484f6f2c7061" providerId="ADAL" clId="{0F8F4826-D65A-4763-AD81-579684985EE3}" dt="2024-03-27T11:07:30.289" v="4" actId="165"/>
          <ac:cxnSpMkLst>
            <pc:docMk/>
            <pc:sldMk cId="2756049766" sldId="256"/>
            <ac:cxnSpMk id="56" creationId="{DBCC6738-52D6-4EA9-B2EB-73AB7FCEAC0F}"/>
          </ac:cxnSpMkLst>
        </pc:cxnChg>
        <pc:cxnChg chg="mod topLvl">
          <ac:chgData name="Tekle Pauzaite" userId="06f7e524-8501-4f81-9b2a-484f6f2c7061" providerId="ADAL" clId="{0F8F4826-D65A-4763-AD81-579684985EE3}" dt="2024-03-27T11:07:30.289" v="4" actId="165"/>
          <ac:cxnSpMkLst>
            <pc:docMk/>
            <pc:sldMk cId="2756049766" sldId="256"/>
            <ac:cxnSpMk id="58" creationId="{EC1D04AD-3E11-4CC3-B748-09FCFF9E0C3A}"/>
          </ac:cxnSpMkLst>
        </pc:cxnChg>
        <pc:cxnChg chg="mod topLvl">
          <ac:chgData name="Tekle Pauzaite" userId="06f7e524-8501-4f81-9b2a-484f6f2c7061" providerId="ADAL" clId="{0F8F4826-D65A-4763-AD81-579684985EE3}" dt="2024-03-27T11:07:30.289" v="4" actId="165"/>
          <ac:cxnSpMkLst>
            <pc:docMk/>
            <pc:sldMk cId="2756049766" sldId="256"/>
            <ac:cxnSpMk id="60" creationId="{2E058224-5CB1-4033-B1E1-A93784D8E390}"/>
          </ac:cxnSpMkLst>
        </pc:cxnChg>
        <pc:cxnChg chg="mod topLvl">
          <ac:chgData name="Tekle Pauzaite" userId="06f7e524-8501-4f81-9b2a-484f6f2c7061" providerId="ADAL" clId="{0F8F4826-D65A-4763-AD81-579684985EE3}" dt="2024-03-27T11:07:30.289" v="4" actId="165"/>
          <ac:cxnSpMkLst>
            <pc:docMk/>
            <pc:sldMk cId="2756049766" sldId="256"/>
            <ac:cxnSpMk id="62" creationId="{22E6DA76-D876-43F2-A8AC-98CC477C75BC}"/>
          </ac:cxnSpMkLst>
        </pc:cxn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2F37226-4537-4166-8582-ABF3026E13D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2953C13E-FC20-48A8-B081-85EB6F66EB1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F35EFE-B1E9-4338-9D68-F4D85C3281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0F5961C-CB27-402C-8ABD-C29FD9DA22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A032CF4-46CE-426B-ADEE-F8CACFD74D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63181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672A7C-4BCC-4F0A-8AB6-969877FA9E9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4DA0AEF-6690-4479-AE8C-5148E4C008D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15A8198-92B3-4667-98D8-A7A4775CF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3134FF-8103-447E-9565-4E096BFA55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53BA963-CCB9-44E7-BF22-B04E908E04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57163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815C14D-889E-473A-BBA1-0B0090530E0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C96356B-004F-4D4E-B84C-3B5726D6D4B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D6E3F92-2F90-493E-96A4-EB83882D17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A8C8257-93C2-4F81-A15A-A97425235E5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7D9F44-4748-4DAA-BEC6-316A8CF699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465547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56072D-4464-4DE4-92D0-409B349B22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61B604F-2F86-4A70-9C55-1545740AEED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8F37CB9-64FB-46A6-B273-E9BC892436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3760BF6-8D57-46B9-AAE6-8330F8BD5D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35ECBE-882E-4E8E-A616-B8821C36E3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29558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E8B3AB-51B2-463D-80C7-83D65E7564D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9909822-FBBD-4361-9ACB-5B0260E6EDA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8AFB3AC-5C6C-4F3A-A208-8C72A5D3B3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FD2045-6E30-42BD-997C-E86673807F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AFB191-7B94-4A2D-B0BB-A02A2DE97B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176474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6764D3-E252-4B50-A5D6-F30737CA64F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41B584-0B67-4C70-9B15-9EF3EEB7B93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682E229-5E73-4CA7-99D2-FF9936F2464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CBB68D4-0A27-4B7F-AD04-09AAA0D659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46C6F68-4A94-4771-ABD7-2A1FB55FDDD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C71D2DF-F55E-4B8B-B9F8-B67FF3D43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890837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618781-E81D-46B3-840D-20A95A6C40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42F7456-C751-4BE5-9882-29883F41AD2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15D26C7-7FEF-4E61-86C4-422C242F0D0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81BD762-FF6D-43D3-9D37-E4E05365126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8019FF3-8C5F-40B2-A426-E50D8E297AF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84773C05-3ADE-4948-A7D3-4C8ED359951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5B79B66-A7B1-4150-9751-2B2FA9E57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59E194E1-17C1-4B7C-B613-F773288676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67191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709B59-976D-4CB9-A927-4C0D9E95A7C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BA16CBF0-61F7-4370-9EB6-1893AD4A14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0675C0E0-F6CB-41D4-B668-A0E1EA76D4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255EB43-A914-4EF2-A063-09488BB0669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04952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BE0E2774-017C-4244-AB0E-D8F591994F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82A5CAD-35AC-4EA8-91A7-EEE492886E1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C9CBCB3-D035-442E-A3FC-E9CE1EB138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8826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17BE6EE-C5C6-4E9C-8EE3-F45A8A6468F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C0ADF94-10DD-40C8-A64C-9A79997AA71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5C50400-0A90-4863-9E8B-D264977B08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03F58D-5799-4CE0-A655-1FC27AB83D9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FDB794-0114-4573-84E8-25F77D078B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0353A2-465B-4423-A6B2-8C1B4072B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946337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5A1E10-9EC8-455A-BB1D-312F86F6AAF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80B075F-5A8D-49CE-8D85-11A35A56A57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1378F5-62CA-49A7-A7A5-151F0C8BAA2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20409D9-AC7B-4499-803B-C885D3E261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808EC33-0A71-4D0C-84D4-C1DAB5ED0E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D93F77-48BC-4662-859D-8B9C84C2AF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61474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46C7C9D-36CF-454A-B2D5-F433343C41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8BBE6AA-6D75-48A2-BE28-1DB812954E8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F87F5E-BFAB-47AB-BC5B-985AC79A07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1B062A-CB56-4BD5-A8A3-351922152E3D}" type="datetimeFigureOut">
              <a:rPr lang="en-GB" smtClean="0"/>
              <a:t>27/03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B15A8D4-DE59-45A9-B9E4-E5EA48CDE66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7542BF-1701-4909-BC0E-224C5470536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4E2514-1FF1-4818-822A-AE506763A3A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21589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AF1C5D3-4B59-45D8-A1BF-7C64496C0A45}"/>
              </a:ext>
            </a:extLst>
          </p:cNvPr>
          <p:cNvSpPr txBox="1"/>
          <p:nvPr/>
        </p:nvSpPr>
        <p:spPr>
          <a:xfrm>
            <a:off x="899286" y="306162"/>
            <a:ext cx="48526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Input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47009CA7-812B-4845-968F-68837B668B85}"/>
              </a:ext>
            </a:extLst>
          </p:cNvPr>
          <p:cNvSpPr txBox="1"/>
          <p:nvPr/>
        </p:nvSpPr>
        <p:spPr>
          <a:xfrm>
            <a:off x="1446859" y="304940"/>
            <a:ext cx="1028358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Streptavidin IP</a:t>
            </a:r>
          </a:p>
        </p:txBody>
      </p:sp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85F5DB18-BFEB-4AFF-8A3C-B440A34A8131}"/>
              </a:ext>
            </a:extLst>
          </p:cNvPr>
          <p:cNvCxnSpPr>
            <a:cxnSpLocks/>
          </p:cNvCxnSpPr>
          <p:nvPr/>
        </p:nvCxnSpPr>
        <p:spPr>
          <a:xfrm>
            <a:off x="761608" y="527379"/>
            <a:ext cx="69507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CE6D4E57-0505-4F0C-B2CA-91536D6F5101}"/>
              </a:ext>
            </a:extLst>
          </p:cNvPr>
          <p:cNvCxnSpPr>
            <a:cxnSpLocks/>
          </p:cNvCxnSpPr>
          <p:nvPr/>
        </p:nvCxnSpPr>
        <p:spPr>
          <a:xfrm>
            <a:off x="1557856" y="527379"/>
            <a:ext cx="695079" cy="0"/>
          </a:xfrm>
          <a:prstGeom prst="line">
            <a:avLst/>
          </a:prstGeom>
          <a:ln w="1905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29BD76FB-DF3E-452F-B97F-3C8C82159399}"/>
              </a:ext>
            </a:extLst>
          </p:cNvPr>
          <p:cNvSpPr txBox="1"/>
          <p:nvPr/>
        </p:nvSpPr>
        <p:spPr>
          <a:xfrm>
            <a:off x="2277513" y="1257483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Streptividin-hP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E0ECA59-7F88-4261-AB19-94464C4D12A9}"/>
              </a:ext>
            </a:extLst>
          </p:cNvPr>
          <p:cNvSpPr txBox="1"/>
          <p:nvPr/>
        </p:nvSpPr>
        <p:spPr>
          <a:xfrm>
            <a:off x="335100" y="959011"/>
            <a:ext cx="38985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A1A4486-7FD2-4CC8-951A-B36E78A8FAF4}"/>
              </a:ext>
            </a:extLst>
          </p:cNvPr>
          <p:cNvSpPr txBox="1"/>
          <p:nvPr/>
        </p:nvSpPr>
        <p:spPr>
          <a:xfrm>
            <a:off x="2277513" y="1698917"/>
            <a:ext cx="605166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D0C84689-3865-41AE-9E74-17D0E85A72A7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9165" t="57303" r="44431" b="18232"/>
          <a:stretch/>
        </p:blipFill>
        <p:spPr>
          <a:xfrm rot="16200000">
            <a:off x="1756096" y="1363427"/>
            <a:ext cx="288210" cy="763649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F5D65AFD-FF95-4604-8E97-A4654D2FD74E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05" t="37021" r="47909" b="14451"/>
          <a:stretch/>
        </p:blipFill>
        <p:spPr>
          <a:xfrm rot="16200000">
            <a:off x="1366753" y="1300624"/>
            <a:ext cx="294226" cy="153632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44BE81CB-9977-4F9B-B12D-C2C0D975E0C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8369" t="21711" r="30213" b="53341"/>
          <a:stretch/>
        </p:blipFill>
        <p:spPr>
          <a:xfrm rot="16200000">
            <a:off x="1303356" y="596178"/>
            <a:ext cx="422843" cy="1534496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7F994290-02E8-4746-9029-929E7B86DA7A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7379" t="54560" r="23482" b="30442"/>
          <a:stretch/>
        </p:blipFill>
        <p:spPr>
          <a:xfrm rot="16200000">
            <a:off x="1753088" y="2007483"/>
            <a:ext cx="294226" cy="76364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4D730270-80FE-4B84-9BCC-FA7967000A6E}"/>
              </a:ext>
            </a:extLst>
          </p:cNvPr>
          <p:cNvSpPr txBox="1"/>
          <p:nvPr/>
        </p:nvSpPr>
        <p:spPr>
          <a:xfrm>
            <a:off x="2277513" y="1993143"/>
            <a:ext cx="379463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B98CAA9C-2809-4EBC-B788-269365BC00E5}"/>
              </a:ext>
            </a:extLst>
          </p:cNvPr>
          <p:cNvSpPr txBox="1"/>
          <p:nvPr/>
        </p:nvSpPr>
        <p:spPr>
          <a:xfrm>
            <a:off x="2277513" y="2313667"/>
            <a:ext cx="1954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(pre-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UbiQ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binding)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661D6D28-1DAA-45C3-8ABE-12000F61928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166" t="12949" r="79681" b="56260"/>
          <a:stretch/>
        </p:blipFill>
        <p:spPr>
          <a:xfrm rot="5400000">
            <a:off x="979266" y="1370308"/>
            <a:ext cx="288211" cy="74988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2FADDEA5-805C-4054-9B32-E5ED4A7248C4}"/>
              </a:ext>
            </a:extLst>
          </p:cNvPr>
          <p:cNvSpPr txBox="1"/>
          <p:nvPr/>
        </p:nvSpPr>
        <p:spPr>
          <a:xfrm>
            <a:off x="2277513" y="478219"/>
            <a:ext cx="823815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253E61FD-50CD-4DAE-BF2A-CD7CE8B49319}"/>
              </a:ext>
            </a:extLst>
          </p:cNvPr>
          <p:cNvSpPr txBox="1"/>
          <p:nvPr/>
        </p:nvSpPr>
        <p:spPr>
          <a:xfrm>
            <a:off x="2277513" y="643469"/>
            <a:ext cx="1084784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C110A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41C5F901-A37F-4E04-9A04-03145026D227}"/>
              </a:ext>
            </a:extLst>
          </p:cNvPr>
          <p:cNvSpPr txBox="1"/>
          <p:nvPr/>
        </p:nvSpPr>
        <p:spPr>
          <a:xfrm>
            <a:off x="2277513" y="808720"/>
            <a:ext cx="127310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</a:t>
            </a:r>
            <a:r>
              <a:rPr lang="en-GB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C110A+H668R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054DFFA6-560B-4039-955C-9A050C86EC10}"/>
              </a:ext>
            </a:extLst>
          </p:cNvPr>
          <p:cNvSpPr txBox="1"/>
          <p:nvPr/>
        </p:nvSpPr>
        <p:spPr>
          <a:xfrm>
            <a:off x="2277513" y="973970"/>
            <a:ext cx="1252298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-USP43 + 65°C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1415845-DADA-4CFD-9414-1A29A42FF13D}"/>
              </a:ext>
            </a:extLst>
          </p:cNvPr>
          <p:cNvSpPr txBox="1"/>
          <p:nvPr/>
        </p:nvSpPr>
        <p:spPr>
          <a:xfrm>
            <a:off x="715510" y="806826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8E46F8D-CEEB-4DA2-B859-4260A8946C74}"/>
              </a:ext>
            </a:extLst>
          </p:cNvPr>
          <p:cNvSpPr txBox="1"/>
          <p:nvPr/>
        </p:nvSpPr>
        <p:spPr>
          <a:xfrm>
            <a:off x="897642" y="806826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0E092B7-09AC-4796-9C00-33B8369E1B86}"/>
              </a:ext>
            </a:extLst>
          </p:cNvPr>
          <p:cNvSpPr txBox="1"/>
          <p:nvPr/>
        </p:nvSpPr>
        <p:spPr>
          <a:xfrm>
            <a:off x="1079774" y="806826"/>
            <a:ext cx="27719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382977CB-9068-4282-A673-112C9CE5AE8C}"/>
              </a:ext>
            </a:extLst>
          </p:cNvPr>
          <p:cNvSpPr txBox="1"/>
          <p:nvPr/>
        </p:nvSpPr>
        <p:spPr>
          <a:xfrm>
            <a:off x="715510" y="953619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0F6F5B8A-73E9-4571-861B-6A27A261B8F3}"/>
              </a:ext>
            </a:extLst>
          </p:cNvPr>
          <p:cNvSpPr txBox="1"/>
          <p:nvPr/>
        </p:nvSpPr>
        <p:spPr>
          <a:xfrm>
            <a:off x="901305" y="953620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784B4BE7-121F-4484-B474-62B3992DFE9C}"/>
              </a:ext>
            </a:extLst>
          </p:cNvPr>
          <p:cNvSpPr txBox="1"/>
          <p:nvPr/>
        </p:nvSpPr>
        <p:spPr>
          <a:xfrm>
            <a:off x="1087102" y="953620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B173EBC-E6AC-4A20-8B71-D9687DFDDF3E}"/>
              </a:ext>
            </a:extLst>
          </p:cNvPr>
          <p:cNvSpPr txBox="1"/>
          <p:nvPr/>
        </p:nvSpPr>
        <p:spPr>
          <a:xfrm>
            <a:off x="715510" y="479534"/>
            <a:ext cx="27719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F15ED44D-25CD-434C-A599-DC86BF67EBDF}"/>
              </a:ext>
            </a:extLst>
          </p:cNvPr>
          <p:cNvSpPr txBox="1"/>
          <p:nvPr/>
        </p:nvSpPr>
        <p:spPr>
          <a:xfrm>
            <a:off x="923290" y="479534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466552DE-3526-4D96-A2B5-78B2E48F3C09}"/>
              </a:ext>
            </a:extLst>
          </p:cNvPr>
          <p:cNvSpPr txBox="1"/>
          <p:nvPr/>
        </p:nvSpPr>
        <p:spPr>
          <a:xfrm>
            <a:off x="1105421" y="479534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6ED9D7B4-5D5B-4E6A-94E4-49190C66DA4B}"/>
              </a:ext>
            </a:extLst>
          </p:cNvPr>
          <p:cNvSpPr txBox="1"/>
          <p:nvPr/>
        </p:nvSpPr>
        <p:spPr>
          <a:xfrm>
            <a:off x="715510" y="626328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B85F809A-DDF7-451F-A679-03563F7B1FA5}"/>
              </a:ext>
            </a:extLst>
          </p:cNvPr>
          <p:cNvSpPr txBox="1"/>
          <p:nvPr/>
        </p:nvSpPr>
        <p:spPr>
          <a:xfrm>
            <a:off x="897642" y="626328"/>
            <a:ext cx="27719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A9C1EBA1-05FF-4CAC-988D-320F774ECF7F}"/>
              </a:ext>
            </a:extLst>
          </p:cNvPr>
          <p:cNvSpPr txBox="1"/>
          <p:nvPr/>
        </p:nvSpPr>
        <p:spPr>
          <a:xfrm>
            <a:off x="1105421" y="626328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F1E085C2-9CFA-452A-B8DC-295D85FEB17E}"/>
              </a:ext>
            </a:extLst>
          </p:cNvPr>
          <p:cNvSpPr txBox="1"/>
          <p:nvPr/>
        </p:nvSpPr>
        <p:spPr>
          <a:xfrm>
            <a:off x="1287554" y="806826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850063B5-8179-4CA4-BBCB-7179FBB97ED6}"/>
              </a:ext>
            </a:extLst>
          </p:cNvPr>
          <p:cNvSpPr txBox="1"/>
          <p:nvPr/>
        </p:nvSpPr>
        <p:spPr>
          <a:xfrm>
            <a:off x="1469686" y="806826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491BCA8B-4C2B-476E-B23A-47E684A186FA}"/>
              </a:ext>
            </a:extLst>
          </p:cNvPr>
          <p:cNvSpPr txBox="1"/>
          <p:nvPr/>
        </p:nvSpPr>
        <p:spPr>
          <a:xfrm>
            <a:off x="1651818" y="806826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89BC0E5-19E2-468B-BBDC-D251D63C0309}"/>
              </a:ext>
            </a:extLst>
          </p:cNvPr>
          <p:cNvSpPr txBox="1"/>
          <p:nvPr/>
        </p:nvSpPr>
        <p:spPr>
          <a:xfrm>
            <a:off x="1272898" y="953620"/>
            <a:ext cx="27719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D3EDA05F-EB50-4D73-AA29-41A29FDE9573}"/>
              </a:ext>
            </a:extLst>
          </p:cNvPr>
          <p:cNvSpPr txBox="1"/>
          <p:nvPr/>
        </p:nvSpPr>
        <p:spPr>
          <a:xfrm>
            <a:off x="1484342" y="953620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6A4D5434-757E-45AE-AD90-BD0F818ACC33}"/>
              </a:ext>
            </a:extLst>
          </p:cNvPr>
          <p:cNvSpPr txBox="1"/>
          <p:nvPr/>
        </p:nvSpPr>
        <p:spPr>
          <a:xfrm>
            <a:off x="1670138" y="953620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AAA0B5F1-A151-4FB7-99E3-0A3F6CCE9F1C}"/>
              </a:ext>
            </a:extLst>
          </p:cNvPr>
          <p:cNvSpPr txBox="1"/>
          <p:nvPr/>
        </p:nvSpPr>
        <p:spPr>
          <a:xfrm>
            <a:off x="1287554" y="479534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0C61A79C-C6EC-4DA4-8FAA-578AB147BFE7}"/>
              </a:ext>
            </a:extLst>
          </p:cNvPr>
          <p:cNvSpPr txBox="1"/>
          <p:nvPr/>
        </p:nvSpPr>
        <p:spPr>
          <a:xfrm>
            <a:off x="1469686" y="479534"/>
            <a:ext cx="27719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45216A81-A4DB-4CD7-AB97-0F7BCE21D4C2}"/>
              </a:ext>
            </a:extLst>
          </p:cNvPr>
          <p:cNvSpPr txBox="1"/>
          <p:nvPr/>
        </p:nvSpPr>
        <p:spPr>
          <a:xfrm>
            <a:off x="1677466" y="479534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84241137-40AB-4A14-B7B7-A9CFF4392585}"/>
              </a:ext>
            </a:extLst>
          </p:cNvPr>
          <p:cNvSpPr txBox="1"/>
          <p:nvPr/>
        </p:nvSpPr>
        <p:spPr>
          <a:xfrm>
            <a:off x="1287554" y="626328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DBCB27EA-CE37-4EC6-9915-6E781D90B120}"/>
              </a:ext>
            </a:extLst>
          </p:cNvPr>
          <p:cNvSpPr txBox="1"/>
          <p:nvPr/>
        </p:nvSpPr>
        <p:spPr>
          <a:xfrm>
            <a:off x="1469686" y="626328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638A4CCE-6BFD-4F9F-9BB9-4075FC8A502E}"/>
              </a:ext>
            </a:extLst>
          </p:cNvPr>
          <p:cNvSpPr txBox="1"/>
          <p:nvPr/>
        </p:nvSpPr>
        <p:spPr>
          <a:xfrm>
            <a:off x="1651818" y="626328"/>
            <a:ext cx="27719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928D9B2-4AF0-4CB2-B042-EEDFE630CC33}"/>
              </a:ext>
            </a:extLst>
          </p:cNvPr>
          <p:cNvSpPr txBox="1"/>
          <p:nvPr/>
        </p:nvSpPr>
        <p:spPr>
          <a:xfrm>
            <a:off x="1833950" y="806826"/>
            <a:ext cx="27719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E1DAE6C8-2DEC-467F-846B-5B1D85C1C043}"/>
              </a:ext>
            </a:extLst>
          </p:cNvPr>
          <p:cNvSpPr txBox="1"/>
          <p:nvPr/>
        </p:nvSpPr>
        <p:spPr>
          <a:xfrm>
            <a:off x="2041733" y="806826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C982DEBB-2AE4-48E8-93F4-9D6741DB6C5E}"/>
              </a:ext>
            </a:extLst>
          </p:cNvPr>
          <p:cNvSpPr txBox="1"/>
          <p:nvPr/>
        </p:nvSpPr>
        <p:spPr>
          <a:xfrm>
            <a:off x="1855934" y="953620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4536AF7-34B6-4602-AD86-0E499B02E955}"/>
              </a:ext>
            </a:extLst>
          </p:cNvPr>
          <p:cNvSpPr txBox="1"/>
          <p:nvPr/>
        </p:nvSpPr>
        <p:spPr>
          <a:xfrm>
            <a:off x="2041733" y="953620"/>
            <a:ext cx="277191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7607EC0-8CD4-41C3-BBCF-3ED53C78346E}"/>
              </a:ext>
            </a:extLst>
          </p:cNvPr>
          <p:cNvSpPr txBox="1"/>
          <p:nvPr/>
        </p:nvSpPr>
        <p:spPr>
          <a:xfrm>
            <a:off x="1859598" y="479534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C1749917-D6C0-4DBD-8394-9BE92114AC40}"/>
              </a:ext>
            </a:extLst>
          </p:cNvPr>
          <p:cNvSpPr txBox="1"/>
          <p:nvPr/>
        </p:nvSpPr>
        <p:spPr>
          <a:xfrm>
            <a:off x="2041733" y="479534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06DE911C-B93F-4A2F-B9CD-51BA099404BB}"/>
              </a:ext>
            </a:extLst>
          </p:cNvPr>
          <p:cNvSpPr txBox="1"/>
          <p:nvPr/>
        </p:nvSpPr>
        <p:spPr>
          <a:xfrm>
            <a:off x="1859598" y="626328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403824B4-8CDC-4B7C-BD9A-AE06E6E3C833}"/>
              </a:ext>
            </a:extLst>
          </p:cNvPr>
          <p:cNvSpPr txBox="1"/>
          <p:nvPr/>
        </p:nvSpPr>
        <p:spPr>
          <a:xfrm>
            <a:off x="2041733" y="626328"/>
            <a:ext cx="245452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9FB4FF72-DF2C-4F04-ABAC-C59515CF50A5}"/>
              </a:ext>
            </a:extLst>
          </p:cNvPr>
          <p:cNvSpPr txBox="1"/>
          <p:nvPr/>
        </p:nvSpPr>
        <p:spPr>
          <a:xfrm>
            <a:off x="348742" y="1237568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56" name="Straight Connector 55">
            <a:extLst>
              <a:ext uri="{FF2B5EF4-FFF2-40B4-BE49-F238E27FC236}">
                <a16:creationId xmlns:a16="http://schemas.microsoft.com/office/drawing/2014/main" id="{DBCC6738-52D6-4EA9-B2EB-73AB7FCEAC0F}"/>
              </a:ext>
            </a:extLst>
          </p:cNvPr>
          <p:cNvCxnSpPr/>
          <p:nvPr/>
        </p:nvCxnSpPr>
        <p:spPr>
          <a:xfrm>
            <a:off x="650197" y="1355196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7" name="TextBox 56">
            <a:extLst>
              <a:ext uri="{FF2B5EF4-FFF2-40B4-BE49-F238E27FC236}">
                <a16:creationId xmlns:a16="http://schemas.microsoft.com/office/drawing/2014/main" id="{CEAD1344-1F1A-4256-A12F-4465466EC74A}"/>
              </a:ext>
            </a:extLst>
          </p:cNvPr>
          <p:cNvSpPr txBox="1"/>
          <p:nvPr/>
        </p:nvSpPr>
        <p:spPr>
          <a:xfrm>
            <a:off x="348742" y="1611177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58" name="Straight Connector 57">
            <a:extLst>
              <a:ext uri="{FF2B5EF4-FFF2-40B4-BE49-F238E27FC236}">
                <a16:creationId xmlns:a16="http://schemas.microsoft.com/office/drawing/2014/main" id="{EC1D04AD-3E11-4CC3-B748-09FCFF9E0C3A}"/>
              </a:ext>
            </a:extLst>
          </p:cNvPr>
          <p:cNvCxnSpPr/>
          <p:nvPr/>
        </p:nvCxnSpPr>
        <p:spPr>
          <a:xfrm>
            <a:off x="650197" y="1728805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0A897402-42E8-4E9C-AECE-47E5A89D9871}"/>
              </a:ext>
            </a:extLst>
          </p:cNvPr>
          <p:cNvSpPr txBox="1"/>
          <p:nvPr/>
        </p:nvSpPr>
        <p:spPr>
          <a:xfrm>
            <a:off x="348742" y="1978746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60" name="Straight Connector 59">
            <a:extLst>
              <a:ext uri="{FF2B5EF4-FFF2-40B4-BE49-F238E27FC236}">
                <a16:creationId xmlns:a16="http://schemas.microsoft.com/office/drawing/2014/main" id="{2E058224-5CB1-4033-B1E1-A93784D8E390}"/>
              </a:ext>
            </a:extLst>
          </p:cNvPr>
          <p:cNvCxnSpPr/>
          <p:nvPr/>
        </p:nvCxnSpPr>
        <p:spPr>
          <a:xfrm>
            <a:off x="650197" y="2096374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1" name="TextBox 60">
            <a:extLst>
              <a:ext uri="{FF2B5EF4-FFF2-40B4-BE49-F238E27FC236}">
                <a16:creationId xmlns:a16="http://schemas.microsoft.com/office/drawing/2014/main" id="{17949836-AA45-4822-94FF-517ED9B50553}"/>
              </a:ext>
            </a:extLst>
          </p:cNvPr>
          <p:cNvSpPr txBox="1"/>
          <p:nvPr/>
        </p:nvSpPr>
        <p:spPr>
          <a:xfrm>
            <a:off x="1119173" y="2263403"/>
            <a:ext cx="283265" cy="17342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148</a:t>
            </a:r>
          </a:p>
        </p:txBody>
      </p:sp>
      <p:cxnSp>
        <p:nvCxnSpPr>
          <p:cNvPr id="62" name="Straight Connector 61">
            <a:extLst>
              <a:ext uri="{FF2B5EF4-FFF2-40B4-BE49-F238E27FC236}">
                <a16:creationId xmlns:a16="http://schemas.microsoft.com/office/drawing/2014/main" id="{22E6DA76-D876-43F2-A8AC-98CC477C75BC}"/>
              </a:ext>
            </a:extLst>
          </p:cNvPr>
          <p:cNvCxnSpPr/>
          <p:nvPr/>
        </p:nvCxnSpPr>
        <p:spPr>
          <a:xfrm>
            <a:off x="1420628" y="2381031"/>
            <a:ext cx="5715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63" name="TextBox 62">
            <a:extLst>
              <a:ext uri="{FF2B5EF4-FFF2-40B4-BE49-F238E27FC236}">
                <a16:creationId xmlns:a16="http://schemas.microsoft.com/office/drawing/2014/main" id="{9940B4AC-227C-4E4C-A606-1C7C3D82EDBC}"/>
              </a:ext>
            </a:extLst>
          </p:cNvPr>
          <p:cNvSpPr txBox="1"/>
          <p:nvPr/>
        </p:nvSpPr>
        <p:spPr>
          <a:xfrm>
            <a:off x="212794" y="38235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F8DAE4BA-B1F3-444E-8FF9-7E40E34BBA8E}"/>
              </a:ext>
            </a:extLst>
          </p:cNvPr>
          <p:cNvSpPr txBox="1"/>
          <p:nvPr/>
        </p:nvSpPr>
        <p:spPr>
          <a:xfrm>
            <a:off x="1443756" y="2543726"/>
            <a:ext cx="98616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EK-293T cells</a:t>
            </a:r>
          </a:p>
        </p:txBody>
      </p:sp>
      <p:pic>
        <p:nvPicPr>
          <p:cNvPr id="65" name="Picture 64">
            <a:extLst>
              <a:ext uri="{FF2B5EF4-FFF2-40B4-BE49-F238E27FC236}">
                <a16:creationId xmlns:a16="http://schemas.microsoft.com/office/drawing/2014/main" id="{C4BA063E-FCE6-4657-B87A-A77DEDA977AB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" t="-229" r="347" b="251"/>
          <a:stretch/>
        </p:blipFill>
        <p:spPr>
          <a:xfrm rot="16200000">
            <a:off x="4755068" y="-584212"/>
            <a:ext cx="2517444" cy="4200095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6" name="Picture 65">
            <a:extLst>
              <a:ext uri="{FF2B5EF4-FFF2-40B4-BE49-F238E27FC236}">
                <a16:creationId xmlns:a16="http://schemas.microsoft.com/office/drawing/2014/main" id="{A48C75BE-79A7-4532-81E4-15FC355C5757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6" t="-129" r="1026" b="1189"/>
          <a:stretch/>
        </p:blipFill>
        <p:spPr>
          <a:xfrm rot="5400000">
            <a:off x="7157815" y="1297211"/>
            <a:ext cx="3775753" cy="164577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7" name="Picture 66">
            <a:extLst>
              <a:ext uri="{FF2B5EF4-FFF2-40B4-BE49-F238E27FC236}">
                <a16:creationId xmlns:a16="http://schemas.microsoft.com/office/drawing/2014/main" id="{91B82F13-FA74-43A8-9590-6824BF30097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12" t="-1515" r="-462" b="3873"/>
          <a:stretch/>
        </p:blipFill>
        <p:spPr>
          <a:xfrm rot="16200000">
            <a:off x="9432986" y="704414"/>
            <a:ext cx="3044676" cy="2081674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8" name="Picture 67">
            <a:extLst>
              <a:ext uri="{FF2B5EF4-FFF2-40B4-BE49-F238E27FC236}">
                <a16:creationId xmlns:a16="http://schemas.microsoft.com/office/drawing/2014/main" id="{ACE4C112-8E02-41C2-959D-4EF8155BF6D2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7" t="-557" r="950" b="1072"/>
          <a:stretch/>
        </p:blipFill>
        <p:spPr>
          <a:xfrm rot="16200000">
            <a:off x="-22258" y="3286315"/>
            <a:ext cx="3644902" cy="3149501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9" name="Picture 68">
            <a:extLst>
              <a:ext uri="{FF2B5EF4-FFF2-40B4-BE49-F238E27FC236}">
                <a16:creationId xmlns:a16="http://schemas.microsoft.com/office/drawing/2014/main" id="{0323699D-90EB-4A80-9DCF-5FF14DFE852B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5" t="-205" r="-624" b="-441"/>
          <a:stretch/>
        </p:blipFill>
        <p:spPr>
          <a:xfrm rot="16200000">
            <a:off x="4398456" y="3195096"/>
            <a:ext cx="2169665" cy="3500154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70" name="Rectangle 69">
            <a:extLst>
              <a:ext uri="{FF2B5EF4-FFF2-40B4-BE49-F238E27FC236}">
                <a16:creationId xmlns:a16="http://schemas.microsoft.com/office/drawing/2014/main" id="{406C0133-FFBF-4734-A53C-B5B55148CE3C}"/>
              </a:ext>
            </a:extLst>
          </p:cNvPr>
          <p:cNvSpPr/>
          <p:nvPr/>
        </p:nvSpPr>
        <p:spPr>
          <a:xfrm>
            <a:off x="4826000" y="933783"/>
            <a:ext cx="1140044" cy="3237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1" name="Rectangle 70">
            <a:extLst>
              <a:ext uri="{FF2B5EF4-FFF2-40B4-BE49-F238E27FC236}">
                <a16:creationId xmlns:a16="http://schemas.microsoft.com/office/drawing/2014/main" id="{3396487E-6A46-4441-8127-331C1A46DE7E}"/>
              </a:ext>
            </a:extLst>
          </p:cNvPr>
          <p:cNvSpPr/>
          <p:nvPr/>
        </p:nvSpPr>
        <p:spPr>
          <a:xfrm>
            <a:off x="9103275" y="762286"/>
            <a:ext cx="570022" cy="3237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43E955FF-A5D7-402B-A544-BB83BDD3D85E}"/>
              </a:ext>
            </a:extLst>
          </p:cNvPr>
          <p:cNvSpPr/>
          <p:nvPr/>
        </p:nvSpPr>
        <p:spPr>
          <a:xfrm>
            <a:off x="11158562" y="1536040"/>
            <a:ext cx="570022" cy="3237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8528722F-5DA7-41DB-881E-B619D44592F4}"/>
              </a:ext>
            </a:extLst>
          </p:cNvPr>
          <p:cNvSpPr/>
          <p:nvPr/>
        </p:nvSpPr>
        <p:spPr>
          <a:xfrm>
            <a:off x="1322056" y="4809077"/>
            <a:ext cx="1725943" cy="3237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4" name="Rectangle 73">
            <a:extLst>
              <a:ext uri="{FF2B5EF4-FFF2-40B4-BE49-F238E27FC236}">
                <a16:creationId xmlns:a16="http://schemas.microsoft.com/office/drawing/2014/main" id="{9AC97B8D-87B7-4A9A-B171-E60D497FBAB9}"/>
              </a:ext>
            </a:extLst>
          </p:cNvPr>
          <p:cNvSpPr/>
          <p:nvPr/>
        </p:nvSpPr>
        <p:spPr>
          <a:xfrm>
            <a:off x="5613400" y="4339177"/>
            <a:ext cx="584199" cy="323700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7421FF90-EF08-4324-BA9A-BC463F7CADB7}"/>
              </a:ext>
            </a:extLst>
          </p:cNvPr>
          <p:cNvSpPr txBox="1"/>
          <p:nvPr/>
        </p:nvSpPr>
        <p:spPr>
          <a:xfrm>
            <a:off x="4877491" y="1285003"/>
            <a:ext cx="93487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Streptividin-hP</a:t>
            </a:r>
            <a:endParaRPr lang="en-GB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CF35BC04-FDAD-4D9F-8FC3-97D20BECED39}"/>
              </a:ext>
            </a:extLst>
          </p:cNvPr>
          <p:cNvSpPr txBox="1"/>
          <p:nvPr/>
        </p:nvSpPr>
        <p:spPr>
          <a:xfrm>
            <a:off x="9077851" y="382358"/>
            <a:ext cx="605166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7" name="TextBox 76">
            <a:extLst>
              <a:ext uri="{FF2B5EF4-FFF2-40B4-BE49-F238E27FC236}">
                <a16:creationId xmlns:a16="http://schemas.microsoft.com/office/drawing/2014/main" id="{F44FE8D8-DEE7-469E-8582-D01873D9BC54}"/>
              </a:ext>
            </a:extLst>
          </p:cNvPr>
          <p:cNvSpPr txBox="1"/>
          <p:nvPr/>
        </p:nvSpPr>
        <p:spPr>
          <a:xfrm>
            <a:off x="11158562" y="1197323"/>
            <a:ext cx="605166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</a:t>
            </a:r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06C713D9-581D-49A5-8192-F270505EC285}"/>
              </a:ext>
            </a:extLst>
          </p:cNvPr>
          <p:cNvSpPr txBox="1"/>
          <p:nvPr/>
        </p:nvSpPr>
        <p:spPr>
          <a:xfrm>
            <a:off x="3065057" y="4843969"/>
            <a:ext cx="379463" cy="25391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HA</a:t>
            </a:r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7EA4CAEE-D3AD-402B-B0B5-47DA2F374059}"/>
              </a:ext>
            </a:extLst>
          </p:cNvPr>
          <p:cNvSpPr txBox="1"/>
          <p:nvPr/>
        </p:nvSpPr>
        <p:spPr>
          <a:xfrm>
            <a:off x="4928223" y="4007976"/>
            <a:ext cx="1954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USP43 (pre- </a:t>
            </a:r>
            <a:r>
              <a:rPr lang="en-GB" sz="900" dirty="0" err="1">
                <a:latin typeface="Arial" panose="020B0604020202020204" pitchFamily="34" charset="0"/>
                <a:cs typeface="Arial" panose="020B0604020202020204" pitchFamily="34" charset="0"/>
              </a:rPr>
              <a:t>UbiQ</a:t>
            </a:r>
            <a:r>
              <a:rPr lang="en-GB" sz="900" dirty="0">
                <a:latin typeface="Arial" panose="020B0604020202020204" pitchFamily="34" charset="0"/>
                <a:cs typeface="Arial" panose="020B0604020202020204" pitchFamily="34" charset="0"/>
              </a:rPr>
              <a:t> binding)</a:t>
            </a:r>
          </a:p>
        </p:txBody>
      </p:sp>
    </p:spTree>
    <p:extLst>
      <p:ext uri="{BB962C8B-B14F-4D97-AF65-F5344CB8AC3E}">
        <p14:creationId xmlns:p14="http://schemas.microsoft.com/office/powerpoint/2010/main" val="275604976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72</Words>
  <Application>Microsoft Office PowerPoint</Application>
  <PresentationFormat>Widescreen</PresentationFormat>
  <Paragraphs>5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ekle Pauzaite</dc:creator>
  <cp:lastModifiedBy>Tekle Pauzaite</cp:lastModifiedBy>
  <cp:revision>1</cp:revision>
  <dcterms:created xsi:type="dcterms:W3CDTF">2024-03-27T11:07:14Z</dcterms:created>
  <dcterms:modified xsi:type="dcterms:W3CDTF">2024-03-27T11:10:31Z</dcterms:modified>
</cp:coreProperties>
</file>